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B7FF3-C756-4E05-BF70-24C2337026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92E1B-DA07-4A14-B049-7DD363433A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A1B7F-039A-4CA0-8B93-A7923BA739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58669-CE16-4C31-9AF0-43854FEDAA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7D16B-D02F-47CB-A109-4D705083F2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B617B-838A-4474-9F62-A9B63129E1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3983C-DB0D-4D88-81B5-B2866D1A19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C45C2-AA39-491F-903C-29E9426D78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30CE0-F57C-40CE-A8D3-D40C6C45D9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31CA3-3CB8-4AC7-9D23-B87732B0D7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361DD-FC4A-46A8-BE88-E00EA0981B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7E6B3-88B6-4C4F-B8B8-3830021A8A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4AD68D-C9EA-48CC-8E2A-2D4561EA58D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61"/>
          <p:cNvGrpSpPr/>
          <p:nvPr/>
        </p:nvGrpSpPr>
        <p:grpSpPr>
          <a:xfrm>
            <a:off x="189000" y="431280"/>
            <a:ext cx="6353640" cy="6132600"/>
            <a:chOff x="189000" y="431280"/>
            <a:chExt cx="6353640" cy="6132600"/>
          </a:xfrm>
        </p:grpSpPr>
        <p:sp>
          <p:nvSpPr>
            <p:cNvPr id="42" name="Rectangle 5"/>
            <p:cNvSpPr/>
            <p:nvPr/>
          </p:nvSpPr>
          <p:spPr>
            <a:xfrm rot="16200000">
              <a:off x="-364320" y="4117680"/>
              <a:ext cx="125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43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equiset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 rot="16200000">
              <a:off x="-237960" y="4117680"/>
              <a:ext cx="125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72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equiset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0"/>
            <p:cNvSpPr/>
            <p:nvPr/>
          </p:nvSpPr>
          <p:spPr>
            <a:xfrm rot="16200000">
              <a:off x="-208440" y="4121640"/>
              <a:ext cx="145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236521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incar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3"/>
            <p:cNvSpPr/>
            <p:nvPr/>
          </p:nvSpPr>
          <p:spPr>
            <a:xfrm rot="16200000">
              <a:off x="-66960" y="3715920"/>
              <a:ext cx="142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20025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venace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5"/>
            <p:cNvSpPr/>
            <p:nvPr/>
          </p:nvSpPr>
          <p:spPr>
            <a:xfrm rot="16200000">
              <a:off x="88920" y="3785760"/>
              <a:ext cx="136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4004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terit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8"/>
            <p:cNvSpPr/>
            <p:nvPr/>
          </p:nvSpPr>
          <p:spPr>
            <a:xfrm rot="16200000">
              <a:off x="79920" y="1172880"/>
              <a:ext cx="163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42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ecemcellula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20"/>
            <p:cNvSpPr/>
            <p:nvPr/>
          </p:nvSpPr>
          <p:spPr>
            <a:xfrm rot="16200000">
              <a:off x="206640" y="1172880"/>
              <a:ext cx="163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42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ecemcellula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23"/>
            <p:cNvSpPr/>
            <p:nvPr/>
          </p:nvSpPr>
          <p:spPr>
            <a:xfrm rot="16200000">
              <a:off x="424440" y="3821760"/>
              <a:ext cx="1452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920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venace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5"/>
            <p:cNvSpPr/>
            <p:nvPr/>
          </p:nvSpPr>
          <p:spPr>
            <a:xfrm rot="16200000">
              <a:off x="595080" y="3891240"/>
              <a:ext cx="136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34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terit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27"/>
            <p:cNvSpPr/>
            <p:nvPr/>
          </p:nvSpPr>
          <p:spPr>
            <a:xfrm rot="16200000">
              <a:off x="712440" y="3876840"/>
              <a:ext cx="1382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55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tricinc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29"/>
            <p:cNvSpPr/>
            <p:nvPr/>
          </p:nvSpPr>
          <p:spPr>
            <a:xfrm rot="16200000">
              <a:off x="717480" y="3941640"/>
              <a:ext cx="162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818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ibberella tricinc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31"/>
            <p:cNvSpPr/>
            <p:nvPr/>
          </p:nvSpPr>
          <p:spPr>
            <a:xfrm rot="16200000">
              <a:off x="1033560" y="3937680"/>
              <a:ext cx="124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393.9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tricinc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6"/>
            <p:cNvSpPr/>
            <p:nvPr/>
          </p:nvSpPr>
          <p:spPr>
            <a:xfrm rot="16200000">
              <a:off x="1026720" y="3577680"/>
              <a:ext cx="151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3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ubglutin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8"/>
            <p:cNvSpPr/>
            <p:nvPr/>
          </p:nvSpPr>
          <p:spPr>
            <a:xfrm rot="16200000">
              <a:off x="1146240" y="3571920"/>
              <a:ext cx="1527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08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0"/>
            <p:cNvSpPr/>
            <p:nvPr/>
          </p:nvSpPr>
          <p:spPr>
            <a:xfrm rot="16200000">
              <a:off x="1324800" y="362268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30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oxysp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42"/>
            <p:cNvSpPr/>
            <p:nvPr/>
          </p:nvSpPr>
          <p:spPr>
            <a:xfrm rot="16200000">
              <a:off x="1451160" y="362232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32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oxysp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4"/>
            <p:cNvSpPr/>
            <p:nvPr/>
          </p:nvSpPr>
          <p:spPr>
            <a:xfrm rot="16200000">
              <a:off x="1579320" y="3612600"/>
              <a:ext cx="142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801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ubglutin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6"/>
            <p:cNvSpPr/>
            <p:nvPr/>
          </p:nvSpPr>
          <p:spPr>
            <a:xfrm rot="16200000">
              <a:off x="1720080" y="3632760"/>
              <a:ext cx="139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576.78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8"/>
            <p:cNvSpPr/>
            <p:nvPr/>
          </p:nvSpPr>
          <p:spPr>
            <a:xfrm rot="16200000">
              <a:off x="1830960" y="3615120"/>
              <a:ext cx="142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0031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50"/>
            <p:cNvSpPr/>
            <p:nvPr/>
          </p:nvSpPr>
          <p:spPr>
            <a:xfrm rot="16200000">
              <a:off x="1916640" y="3597480"/>
              <a:ext cx="150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65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rolifer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52"/>
            <p:cNvSpPr/>
            <p:nvPr/>
          </p:nvSpPr>
          <p:spPr>
            <a:xfrm rot="16200000">
              <a:off x="2110680" y="3658320"/>
              <a:ext cx="1370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216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rolifer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56"/>
            <p:cNvSpPr/>
            <p:nvPr/>
          </p:nvSpPr>
          <p:spPr>
            <a:xfrm rot="16200000">
              <a:off x="2261160" y="2808000"/>
              <a:ext cx="1323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46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ime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8"/>
            <p:cNvSpPr/>
            <p:nvPr/>
          </p:nvSpPr>
          <p:spPr>
            <a:xfrm rot="16200000">
              <a:off x="2467800" y="1758240"/>
              <a:ext cx="1187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2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ime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62"/>
            <p:cNvSpPr/>
            <p:nvPr/>
          </p:nvSpPr>
          <p:spPr>
            <a:xfrm rot="16200000">
              <a:off x="2303280" y="2900160"/>
              <a:ext cx="174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538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64"/>
            <p:cNvSpPr/>
            <p:nvPr/>
          </p:nvSpPr>
          <p:spPr>
            <a:xfrm rot="16200000">
              <a:off x="2790720" y="2159280"/>
              <a:ext cx="102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BRC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505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66"/>
            <p:cNvSpPr/>
            <p:nvPr/>
          </p:nvSpPr>
          <p:spPr>
            <a:xfrm rot="16200000">
              <a:off x="2847960" y="2219040"/>
              <a:ext cx="116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9038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73"/>
            <p:cNvSpPr/>
            <p:nvPr/>
          </p:nvSpPr>
          <p:spPr>
            <a:xfrm rot="16200000">
              <a:off x="2876760" y="4068000"/>
              <a:ext cx="135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264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siatic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75"/>
            <p:cNvSpPr/>
            <p:nvPr/>
          </p:nvSpPr>
          <p:spPr>
            <a:xfrm rot="16200000">
              <a:off x="2991240" y="4057200"/>
              <a:ext cx="1381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1212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culm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77"/>
            <p:cNvSpPr/>
            <p:nvPr/>
          </p:nvSpPr>
          <p:spPr>
            <a:xfrm rot="16200000">
              <a:off x="3027240" y="3961800"/>
              <a:ext cx="1562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27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gramine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81"/>
            <p:cNvSpPr/>
            <p:nvPr/>
          </p:nvSpPr>
          <p:spPr>
            <a:xfrm rot="16200000">
              <a:off x="3278520" y="4131360"/>
              <a:ext cx="1312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RRL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490 F. kyushu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83"/>
            <p:cNvSpPr/>
            <p:nvPr/>
          </p:nvSpPr>
          <p:spPr>
            <a:xfrm rot="16200000">
              <a:off x="3328920" y="4060800"/>
              <a:ext cx="1465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64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kyushu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85"/>
            <p:cNvSpPr/>
            <p:nvPr/>
          </p:nvSpPr>
          <p:spPr>
            <a:xfrm rot="16200000">
              <a:off x="3543120" y="4039560"/>
              <a:ext cx="1289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99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87"/>
            <p:cNvSpPr/>
            <p:nvPr/>
          </p:nvSpPr>
          <p:spPr>
            <a:xfrm rot="16200000">
              <a:off x="3522240" y="3883320"/>
              <a:ext cx="158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491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89"/>
            <p:cNvSpPr/>
            <p:nvPr/>
          </p:nvSpPr>
          <p:spPr>
            <a:xfrm rot="16200000">
              <a:off x="3601800" y="3848040"/>
              <a:ext cx="1678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639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91"/>
            <p:cNvSpPr/>
            <p:nvPr/>
          </p:nvSpPr>
          <p:spPr>
            <a:xfrm rot="16200000">
              <a:off x="3780720" y="3891600"/>
              <a:ext cx="157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9839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93"/>
            <p:cNvSpPr/>
            <p:nvPr/>
          </p:nvSpPr>
          <p:spPr>
            <a:xfrm rot="16200000">
              <a:off x="4006080" y="4008600"/>
              <a:ext cx="1376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485.9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cumi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95"/>
            <p:cNvSpPr/>
            <p:nvPr/>
          </p:nvSpPr>
          <p:spPr>
            <a:xfrm rot="16200000">
              <a:off x="4144320" y="4004280"/>
              <a:ext cx="135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100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97"/>
            <p:cNvSpPr/>
            <p:nvPr/>
          </p:nvSpPr>
          <p:spPr>
            <a:xfrm rot="16200000">
              <a:off x="4270680" y="4013280"/>
              <a:ext cx="135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323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99"/>
            <p:cNvSpPr/>
            <p:nvPr/>
          </p:nvSpPr>
          <p:spPr>
            <a:xfrm rot="16200000">
              <a:off x="4317840" y="3947400"/>
              <a:ext cx="151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71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cumi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06"/>
            <p:cNvSpPr/>
            <p:nvPr/>
          </p:nvSpPr>
          <p:spPr>
            <a:xfrm rot="16200000">
              <a:off x="4642200" y="5139360"/>
              <a:ext cx="1116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05947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po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08"/>
            <p:cNvSpPr/>
            <p:nvPr/>
          </p:nvSpPr>
          <p:spPr>
            <a:xfrm rot="16200000">
              <a:off x="4852800" y="5209200"/>
              <a:ext cx="94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796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po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12"/>
            <p:cNvSpPr/>
            <p:nvPr/>
          </p:nvSpPr>
          <p:spPr>
            <a:xfrm rot="16200000">
              <a:off x="4766040" y="4907880"/>
              <a:ext cx="1375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4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merism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14"/>
            <p:cNvSpPr/>
            <p:nvPr/>
          </p:nvSpPr>
          <p:spPr>
            <a:xfrm rot="16200000">
              <a:off x="4824720" y="5064480"/>
              <a:ext cx="151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50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merism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16"/>
            <p:cNvSpPr/>
            <p:nvPr/>
          </p:nvSpPr>
          <p:spPr>
            <a:xfrm rot="16200000">
              <a:off x="5111280" y="4951080"/>
              <a:ext cx="119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69.3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rv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18"/>
            <p:cNvSpPr/>
            <p:nvPr/>
          </p:nvSpPr>
          <p:spPr>
            <a:xfrm rot="16200000">
              <a:off x="5238000" y="5058360"/>
              <a:ext cx="119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8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rv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24"/>
            <p:cNvSpPr/>
            <p:nvPr/>
          </p:nvSpPr>
          <p:spPr>
            <a:xfrm rot="16200000">
              <a:off x="5275440" y="4521960"/>
              <a:ext cx="1369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R74A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urospora cras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27"/>
            <p:cNvSpPr/>
            <p:nvPr/>
          </p:nvSpPr>
          <p:spPr>
            <a:xfrm rot="16200000">
              <a:off x="5177160" y="4756320"/>
              <a:ext cx="181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68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icrodochium niv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29"/>
            <p:cNvSpPr/>
            <p:nvPr/>
          </p:nvSpPr>
          <p:spPr>
            <a:xfrm rot="16200000">
              <a:off x="5355720" y="4907160"/>
              <a:ext cx="171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620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icrodochium niv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33"/>
            <p:cNvSpPr/>
            <p:nvPr/>
          </p:nvSpPr>
          <p:spPr>
            <a:xfrm rot="16200000">
              <a:off x="5698080" y="4370400"/>
              <a:ext cx="1283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IB4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spergillus oryz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35"/>
            <p:cNvSpPr/>
            <p:nvPr/>
          </p:nvSpPr>
          <p:spPr>
            <a:xfrm rot="16200000">
              <a:off x="5326560" y="5347800"/>
              <a:ext cx="227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isconsin 54-1255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nicillium chrysoge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グループ化 160"/>
          <p:cNvGrpSpPr/>
          <p:nvPr/>
        </p:nvGrpSpPr>
        <p:grpSpPr>
          <a:xfrm>
            <a:off x="200160" y="2422080"/>
            <a:ext cx="6327000" cy="6208920"/>
            <a:chOff x="200160" y="2422080"/>
            <a:chExt cx="6327000" cy="6208920"/>
          </a:xfrm>
        </p:grpSpPr>
        <p:sp>
          <p:nvSpPr>
            <p:cNvPr id="93" name="Rectangle 146"/>
            <p:cNvSpPr/>
            <p:nvPr/>
          </p:nvSpPr>
          <p:spPr>
            <a:xfrm rot="16200000">
              <a:off x="615240" y="487260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4" name="グループ化 157"/>
            <p:cNvGrpSpPr/>
            <p:nvPr/>
          </p:nvGrpSpPr>
          <p:grpSpPr>
            <a:xfrm>
              <a:off x="200160" y="2422080"/>
              <a:ext cx="6327000" cy="6208920"/>
              <a:chOff x="200160" y="2422080"/>
              <a:chExt cx="6327000" cy="6208920"/>
            </a:xfrm>
          </p:grpSpPr>
          <p:sp>
            <p:nvSpPr>
              <p:cNvPr id="95" name="Rectangle 147"/>
              <p:cNvSpPr/>
              <p:nvPr/>
            </p:nvSpPr>
            <p:spPr>
              <a:xfrm rot="16200000">
                <a:off x="208800" y="51645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7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6" name="グループ化 213"/>
              <p:cNvGrpSpPr/>
              <p:nvPr/>
            </p:nvGrpSpPr>
            <p:grpSpPr>
              <a:xfrm>
                <a:off x="287280" y="2422080"/>
                <a:ext cx="6239880" cy="6208920"/>
                <a:chOff x="287280" y="2422080"/>
                <a:chExt cx="6239880" cy="6208920"/>
              </a:xfrm>
            </p:grpSpPr>
            <p:sp>
              <p:nvSpPr>
                <p:cNvPr id="97" name="Freeform 6"/>
                <p:cNvSpPr/>
                <p:nvPr/>
              </p:nvSpPr>
              <p:spPr>
                <a:xfrm rot="16200000">
                  <a:off x="314640" y="513036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Freeform 8"/>
                <p:cNvSpPr/>
                <p:nvPr/>
              </p:nvSpPr>
              <p:spPr>
                <a:xfrm rot="16200000">
                  <a:off x="383400" y="513036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Freeform 9"/>
                <p:cNvSpPr/>
                <p:nvPr/>
              </p:nvSpPr>
              <p:spPr>
                <a:xfrm rot="16200000">
                  <a:off x="339120" y="5169600"/>
                  <a:ext cx="109440" cy="88200"/>
                </a:xfrm>
                <a:custGeom>
                  <a:avLst/>
                  <a:gdLst>
                    <a:gd name="textAreaLeft" fmla="*/ 0 w 109440"/>
                    <a:gd name="textAreaRight" fmla="*/ 109800 w 10944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69" h="69">
                      <a:moveTo>
                        <a:pt x="0" y="69"/>
                      </a:moveTo>
                      <a:lnTo>
                        <a:pt x="0" y="0"/>
                      </a:lnTo>
                      <a:lnTo>
                        <a:pt x="6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Freeform 11"/>
                <p:cNvSpPr/>
                <p:nvPr/>
              </p:nvSpPr>
              <p:spPr>
                <a:xfrm rot="16200000">
                  <a:off x="493920" y="5223600"/>
                  <a:ext cx="1440" cy="882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1588" h="69">
                      <a:moveTo>
                        <a:pt x="0" y="0"/>
                      </a:moveTo>
                      <a:lnTo>
                        <a:pt x="0" y="69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Freeform 12"/>
                <p:cNvSpPr/>
                <p:nvPr/>
              </p:nvSpPr>
              <p:spPr>
                <a:xfrm rot="16200000">
                  <a:off x="878760" y="4834440"/>
                  <a:ext cx="21960" cy="891000"/>
                </a:xfrm>
                <a:custGeom>
                  <a:avLst/>
                  <a:gdLst>
                    <a:gd name="textAreaLeft" fmla="*/ 0 w 21960"/>
                    <a:gd name="textAreaRight" fmla="*/ 22320 w 21960"/>
                    <a:gd name="textAreaTop" fmla="*/ 0 h 891000"/>
                    <a:gd name="textAreaBottom" fmla="*/ 891360 h 891000"/>
                  </a:gdLst>
                  <a:ahLst/>
                  <a:rect l="textAreaLeft" t="textAreaTop" r="textAreaRight" b="textAreaBottom"/>
                  <a:pathLst>
                    <a:path w="14" h="697">
                      <a:moveTo>
                        <a:pt x="0" y="697"/>
                      </a:moveTo>
                      <a:lnTo>
                        <a:pt x="0" y="0"/>
                      </a:lnTo>
                      <a:lnTo>
                        <a:pt x="1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Freeform 14"/>
                <p:cNvSpPr/>
                <p:nvPr/>
              </p:nvSpPr>
              <p:spPr>
                <a:xfrm rot="16200000">
                  <a:off x="691920" y="4840560"/>
                  <a:ext cx="1440" cy="572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1588" h="45">
                      <a:moveTo>
                        <a:pt x="0" y="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Freeform 16"/>
                <p:cNvSpPr/>
                <p:nvPr/>
              </p:nvSpPr>
              <p:spPr>
                <a:xfrm rot="16200000">
                  <a:off x="761760" y="484128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Freeform 17"/>
                <p:cNvSpPr/>
                <p:nvPr/>
              </p:nvSpPr>
              <p:spPr>
                <a:xfrm rot="16200000">
                  <a:off x="734400" y="4863600"/>
                  <a:ext cx="106200" cy="11880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118800"/>
                    <a:gd name="textAreaBottom" fmla="*/ 119160 h 118800"/>
                  </a:gdLst>
                  <a:ahLst/>
                  <a:rect l="textAreaLeft" t="textAreaTop" r="textAreaRight" b="textAreaBottom"/>
                  <a:pathLst>
                    <a:path w="67" h="93">
                      <a:moveTo>
                        <a:pt x="0" y="93"/>
                      </a:moveTo>
                      <a:lnTo>
                        <a:pt x="0" y="0"/>
                      </a:lnTo>
                      <a:lnTo>
                        <a:pt x="6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Freeform 19"/>
                <p:cNvSpPr/>
                <p:nvPr/>
              </p:nvSpPr>
              <p:spPr>
                <a:xfrm rot="16200000">
                  <a:off x="944640" y="239472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Freeform 21"/>
                <p:cNvSpPr/>
                <p:nvPr/>
              </p:nvSpPr>
              <p:spPr>
                <a:xfrm rot="16200000">
                  <a:off x="1013760" y="239472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Freeform 22"/>
                <p:cNvSpPr/>
                <p:nvPr/>
              </p:nvSpPr>
              <p:spPr>
                <a:xfrm rot="16200000">
                  <a:off x="-356400" y="3639960"/>
                  <a:ext cx="2552760" cy="119880"/>
                </a:xfrm>
                <a:custGeom>
                  <a:avLst/>
                  <a:gdLst>
                    <a:gd name="textAreaLeft" fmla="*/ 0 w 2552760"/>
                    <a:gd name="textAreaRight" fmla="*/ 2553120 w 2552760"/>
                    <a:gd name="textAreaTop" fmla="*/ 0 h 119880"/>
                    <a:gd name="textAreaBottom" fmla="*/ 120240 h 119880"/>
                  </a:gdLst>
                  <a:ahLst/>
                  <a:rect l="textAreaLeft" t="textAreaTop" r="textAreaRight" b="textAreaBottom"/>
                  <a:pathLst>
                    <a:path w="1608" h="94">
                      <a:moveTo>
                        <a:pt x="0" y="0"/>
                      </a:moveTo>
                      <a:lnTo>
                        <a:pt x="0" y="94"/>
                      </a:lnTo>
                      <a:lnTo>
                        <a:pt x="1608" y="9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Freeform 24"/>
                <p:cNvSpPr/>
                <p:nvPr/>
              </p:nvSpPr>
              <p:spPr>
                <a:xfrm rot="16200000">
                  <a:off x="1227960" y="4916160"/>
                  <a:ext cx="1440" cy="1188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18800"/>
                    <a:gd name="textAreaBottom" fmla="*/ 119160 h 118800"/>
                  </a:gdLst>
                  <a:ahLst/>
                  <a:rect l="textAreaLeft" t="textAreaTop" r="textAreaRight" b="textAreaBottom"/>
                  <a:pathLst>
                    <a:path w="1588" h="93">
                      <a:moveTo>
                        <a:pt x="0" y="93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Freeform 26"/>
                <p:cNvSpPr/>
                <p:nvPr/>
              </p:nvSpPr>
              <p:spPr>
                <a:xfrm rot="16200000">
                  <a:off x="1322280" y="4946760"/>
                  <a:ext cx="1440" cy="572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1588" h="45">
                      <a:moveTo>
                        <a:pt x="0" y="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Freeform 28"/>
                <p:cNvSpPr/>
                <p:nvPr/>
              </p:nvSpPr>
              <p:spPr>
                <a:xfrm rot="16200000">
                  <a:off x="1392120" y="494748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Freeform 30"/>
                <p:cNvSpPr/>
                <p:nvPr/>
              </p:nvSpPr>
              <p:spPr>
                <a:xfrm rot="16200000">
                  <a:off x="1575000" y="494748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Freeform 32"/>
                <p:cNvSpPr/>
                <p:nvPr/>
              </p:nvSpPr>
              <p:spPr>
                <a:xfrm rot="16200000">
                  <a:off x="1644120" y="494748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Line 33"/>
                <p:cNvSpPr/>
                <p:nvPr/>
              </p:nvSpPr>
              <p:spPr>
                <a:xfrm flipV="1">
                  <a:off x="728280" y="4974840"/>
                  <a:ext cx="46656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Line 34"/>
                <p:cNvSpPr/>
                <p:nvPr/>
              </p:nvSpPr>
              <p:spPr>
                <a:xfrm flipV="1">
                  <a:off x="1206360" y="4974840"/>
                  <a:ext cx="46656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Freeform 35"/>
                <p:cNvSpPr/>
                <p:nvPr/>
              </p:nvSpPr>
              <p:spPr>
                <a:xfrm rot="16200000">
                  <a:off x="1663200" y="4513320"/>
                  <a:ext cx="107640" cy="1034280"/>
                </a:xfrm>
                <a:custGeom>
                  <a:avLst/>
                  <a:gdLst>
                    <a:gd name="textAreaLeft" fmla="*/ 0 w 107640"/>
                    <a:gd name="textAreaRight" fmla="*/ 108000 w 107640"/>
                    <a:gd name="textAreaTop" fmla="*/ 0 h 1034280"/>
                    <a:gd name="textAreaBottom" fmla="*/ 1034640 h 1034280"/>
                  </a:gdLst>
                  <a:ahLst/>
                  <a:rect l="textAreaLeft" t="textAreaTop" r="textAreaRight" b="textAreaBottom"/>
                  <a:pathLst>
                    <a:path w="68" h="809">
                      <a:moveTo>
                        <a:pt x="0" y="809"/>
                      </a:moveTo>
                      <a:lnTo>
                        <a:pt x="0" y="0"/>
                      </a:lnTo>
                      <a:lnTo>
                        <a:pt x="6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Freeform 37"/>
                <p:cNvSpPr/>
                <p:nvPr/>
              </p:nvSpPr>
              <p:spPr>
                <a:xfrm rot="16200000">
                  <a:off x="2047320" y="4507920"/>
                  <a:ext cx="1440" cy="497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497160"/>
                    <a:gd name="textAreaBottom" fmla="*/ 497520 h 497160"/>
                  </a:gdLst>
                  <a:ahLst/>
                  <a:rect l="textAreaLeft" t="textAreaTop" r="textAreaRight" b="textAreaBottom"/>
                  <a:pathLst>
                    <a:path w="1588" h="389">
                      <a:moveTo>
                        <a:pt x="0" y="389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Freeform 39"/>
                <p:cNvSpPr/>
                <p:nvPr/>
              </p:nvSpPr>
              <p:spPr>
                <a:xfrm rot="16200000">
                  <a:off x="2141280" y="4539240"/>
                  <a:ext cx="1440" cy="43452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434520"/>
                    <a:gd name="textAreaBottom" fmla="*/ 434880 h 434520"/>
                  </a:gdLst>
                  <a:ahLst/>
                  <a:rect l="textAreaLeft" t="textAreaTop" r="textAreaRight" b="textAreaBottom"/>
                  <a:pathLst>
                    <a:path w="1588" h="340">
                      <a:moveTo>
                        <a:pt x="0" y="34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Freeform 41"/>
                <p:cNvSpPr/>
                <p:nvPr/>
              </p:nvSpPr>
              <p:spPr>
                <a:xfrm rot="16200000">
                  <a:off x="2172960" y="4633920"/>
                  <a:ext cx="1440" cy="245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245160"/>
                    <a:gd name="textAreaBottom" fmla="*/ 245520 h 245160"/>
                  </a:gdLst>
                  <a:ahLst/>
                  <a:rect l="textAreaLeft" t="textAreaTop" r="textAreaRight" b="textAreaBottom"/>
                  <a:pathLst>
                    <a:path w="1588" h="192">
                      <a:moveTo>
                        <a:pt x="0" y="192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Freeform 43"/>
                <p:cNvSpPr/>
                <p:nvPr/>
              </p:nvSpPr>
              <p:spPr>
                <a:xfrm rot="16200000">
                  <a:off x="2266920" y="4665240"/>
                  <a:ext cx="1440" cy="18252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82520"/>
                    <a:gd name="textAreaBottom" fmla="*/ 182880 h 182520"/>
                  </a:gdLst>
                  <a:ahLst/>
                  <a:rect l="textAreaLeft" t="textAreaTop" r="textAreaRight" b="textAreaBottom"/>
                  <a:pathLst>
                    <a:path w="1588" h="143">
                      <a:moveTo>
                        <a:pt x="0" y="143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Freeform 45"/>
                <p:cNvSpPr/>
                <p:nvPr/>
              </p:nvSpPr>
              <p:spPr>
                <a:xfrm rot="16200000">
                  <a:off x="2362320" y="4696560"/>
                  <a:ext cx="1440" cy="11988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19880"/>
                    <a:gd name="textAreaBottom" fmla="*/ 120240 h 119880"/>
                  </a:gdLst>
                  <a:ahLst/>
                  <a:rect l="textAreaLeft" t="textAreaTop" r="textAreaRight" b="textAreaBottom"/>
                  <a:pathLst>
                    <a:path w="1588" h="94">
                      <a:moveTo>
                        <a:pt x="0" y="9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Freeform 47"/>
                <p:cNvSpPr/>
                <p:nvPr/>
              </p:nvSpPr>
              <p:spPr>
                <a:xfrm rot="16200000">
                  <a:off x="2457360" y="472860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Freeform 49"/>
                <p:cNvSpPr/>
                <p:nvPr/>
              </p:nvSpPr>
              <p:spPr>
                <a:xfrm rot="16200000">
                  <a:off x="2526120" y="472860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Freeform 51"/>
                <p:cNvSpPr/>
                <p:nvPr/>
              </p:nvSpPr>
              <p:spPr>
                <a:xfrm rot="16200000">
                  <a:off x="2709000" y="472860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Freeform 53"/>
                <p:cNvSpPr/>
                <p:nvPr/>
              </p:nvSpPr>
              <p:spPr>
                <a:xfrm rot="16200000">
                  <a:off x="2778120" y="472860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54"/>
                <p:cNvSpPr/>
                <p:nvPr/>
              </p:nvSpPr>
              <p:spPr>
                <a:xfrm flipV="1">
                  <a:off x="2309760" y="4755960"/>
                  <a:ext cx="49716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Freeform 55"/>
                <p:cNvSpPr/>
                <p:nvPr/>
              </p:nvSpPr>
              <p:spPr>
                <a:xfrm rot="16200000">
                  <a:off x="2379600" y="4681080"/>
                  <a:ext cx="187200" cy="339840"/>
                </a:xfrm>
                <a:custGeom>
                  <a:avLst/>
                  <a:gdLst>
                    <a:gd name="textAreaLeft" fmla="*/ 0 w 187200"/>
                    <a:gd name="textAreaRight" fmla="*/ 187560 w 187200"/>
                    <a:gd name="textAreaTop" fmla="*/ 0 h 339840"/>
                    <a:gd name="textAreaBottom" fmla="*/ 340200 h 339840"/>
                  </a:gdLst>
                  <a:ahLst/>
                  <a:rect l="textAreaLeft" t="textAreaTop" r="textAreaRight" b="textAreaBottom"/>
                  <a:pathLst>
                    <a:path w="118" h="266">
                      <a:moveTo>
                        <a:pt x="0" y="266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Freeform 57"/>
                <p:cNvSpPr/>
                <p:nvPr/>
              </p:nvSpPr>
              <p:spPr>
                <a:xfrm rot="16200000">
                  <a:off x="2767320" y="4060080"/>
                  <a:ext cx="388800" cy="56160"/>
                </a:xfrm>
                <a:custGeom>
                  <a:avLst/>
                  <a:gdLst>
                    <a:gd name="textAreaLeft" fmla="*/ 0 w 388800"/>
                    <a:gd name="textAreaRight" fmla="*/ 389160 w 38880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245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4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Freeform 59"/>
                <p:cNvSpPr/>
                <p:nvPr/>
              </p:nvSpPr>
              <p:spPr>
                <a:xfrm rot="16200000">
                  <a:off x="2256480" y="3480480"/>
                  <a:ext cx="1547640" cy="56160"/>
                </a:xfrm>
                <a:custGeom>
                  <a:avLst/>
                  <a:gdLst>
                    <a:gd name="textAreaLeft" fmla="*/ 0 w 1547640"/>
                    <a:gd name="textAreaRight" fmla="*/ 1548000 w 15476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975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975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Freeform 60"/>
                <p:cNvSpPr/>
                <p:nvPr/>
              </p:nvSpPr>
              <p:spPr>
                <a:xfrm rot="16200000">
                  <a:off x="2494800" y="4443480"/>
                  <a:ext cx="662040" cy="339840"/>
                </a:xfrm>
                <a:custGeom>
                  <a:avLst/>
                  <a:gdLst>
                    <a:gd name="textAreaLeft" fmla="*/ 0 w 662040"/>
                    <a:gd name="textAreaRight" fmla="*/ 662400 w 662040"/>
                    <a:gd name="textAreaTop" fmla="*/ 0 h 339840"/>
                    <a:gd name="textAreaBottom" fmla="*/ 340200 h 339840"/>
                  </a:gdLst>
                  <a:ahLst/>
                  <a:rect l="textAreaLeft" t="textAreaTop" r="textAreaRight" b="textAreaBottom"/>
                  <a:pathLst>
                    <a:path w="417" h="266">
                      <a:moveTo>
                        <a:pt x="0" y="0"/>
                      </a:moveTo>
                      <a:lnTo>
                        <a:pt x="0" y="266"/>
                      </a:lnTo>
                      <a:lnTo>
                        <a:pt x="417" y="26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Freeform 61"/>
                <p:cNvSpPr/>
                <p:nvPr/>
              </p:nvSpPr>
              <p:spPr>
                <a:xfrm rot="16200000">
                  <a:off x="2734200" y="4859640"/>
                  <a:ext cx="139680" cy="309240"/>
                </a:xfrm>
                <a:custGeom>
                  <a:avLst/>
                  <a:gdLst>
                    <a:gd name="textAreaLeft" fmla="*/ 0 w 139680"/>
                    <a:gd name="textAreaRight" fmla="*/ 140040 w 139680"/>
                    <a:gd name="textAreaTop" fmla="*/ 0 h 309240"/>
                    <a:gd name="textAreaBottom" fmla="*/ 309600 h 309240"/>
                  </a:gdLst>
                  <a:ahLst/>
                  <a:rect l="textAreaLeft" t="textAreaTop" r="textAreaRight" b="textAreaBottom"/>
                  <a:pathLst>
                    <a:path w="88" h="242">
                      <a:moveTo>
                        <a:pt x="0" y="242"/>
                      </a:moveTo>
                      <a:lnTo>
                        <a:pt x="0" y="0"/>
                      </a:lnTo>
                      <a:lnTo>
                        <a:pt x="8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63"/>
                <p:cNvSpPr/>
                <p:nvPr/>
              </p:nvSpPr>
              <p:spPr>
                <a:xfrm rot="16200000">
                  <a:off x="3178440" y="3900240"/>
                  <a:ext cx="101520" cy="88200"/>
                </a:xfrm>
                <a:custGeom>
                  <a:avLst/>
                  <a:gdLst>
                    <a:gd name="textAreaLeft" fmla="*/ 0 w 101520"/>
                    <a:gd name="textAreaRight" fmla="*/ 101880 w 10152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64" h="69">
                      <a:moveTo>
                        <a:pt x="0" y="69"/>
                      </a:moveTo>
                      <a:lnTo>
                        <a:pt x="0" y="0"/>
                      </a:lnTo>
                      <a:lnTo>
                        <a:pt x="6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Freeform 65"/>
                <p:cNvSpPr/>
                <p:nvPr/>
              </p:nvSpPr>
              <p:spPr>
                <a:xfrm rot="16200000">
                  <a:off x="2989080" y="3403440"/>
                  <a:ext cx="701640" cy="56160"/>
                </a:xfrm>
                <a:custGeom>
                  <a:avLst/>
                  <a:gdLst>
                    <a:gd name="textAreaLeft" fmla="*/ 0 w 701640"/>
                    <a:gd name="textAreaRight" fmla="*/ 702000 w 7016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442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442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Freeform 67"/>
                <p:cNvSpPr/>
                <p:nvPr/>
              </p:nvSpPr>
              <p:spPr>
                <a:xfrm rot="16200000">
                  <a:off x="3120120" y="3465360"/>
                  <a:ext cx="577800" cy="56160"/>
                </a:xfrm>
                <a:custGeom>
                  <a:avLst/>
                  <a:gdLst>
                    <a:gd name="textAreaLeft" fmla="*/ 0 w 577800"/>
                    <a:gd name="textAreaRight" fmla="*/ 578160 w 57780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364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364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68"/>
                <p:cNvSpPr/>
                <p:nvPr/>
              </p:nvSpPr>
              <p:spPr>
                <a:xfrm rot="16200000">
                  <a:off x="3224160" y="3844800"/>
                  <a:ext cx="212400" cy="88200"/>
                </a:xfrm>
                <a:custGeom>
                  <a:avLst/>
                  <a:gdLst>
                    <a:gd name="textAreaLeft" fmla="*/ 0 w 212400"/>
                    <a:gd name="textAreaRight" fmla="*/ 212760 w 212400"/>
                    <a:gd name="textAreaTop" fmla="*/ 0 h 88200"/>
                    <a:gd name="textAreaBottom" fmla="*/ 88560 h 88200"/>
                  </a:gdLst>
                  <a:ahLst/>
                  <a:rect l="textAreaLeft" t="textAreaTop" r="textAreaRight" b="textAreaBottom"/>
                  <a:pathLst>
                    <a:path w="134" h="69">
                      <a:moveTo>
                        <a:pt x="0" y="0"/>
                      </a:moveTo>
                      <a:lnTo>
                        <a:pt x="0" y="69"/>
                      </a:lnTo>
                      <a:lnTo>
                        <a:pt x="134" y="69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760" bIns="41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Freeform 69"/>
                <p:cNvSpPr/>
                <p:nvPr/>
              </p:nvSpPr>
              <p:spPr>
                <a:xfrm rot="16200000">
                  <a:off x="2580840" y="4385160"/>
                  <a:ext cx="1089000" cy="309240"/>
                </a:xfrm>
                <a:custGeom>
                  <a:avLst/>
                  <a:gdLst>
                    <a:gd name="textAreaLeft" fmla="*/ 0 w 1089000"/>
                    <a:gd name="textAreaRight" fmla="*/ 1089000 w 1089000"/>
                    <a:gd name="textAreaTop" fmla="*/ 0 h 309240"/>
                    <a:gd name="textAreaBottom" fmla="*/ 309600 h 309240"/>
                  </a:gdLst>
                  <a:ahLst/>
                  <a:rect l="textAreaLeft" t="textAreaTop" r="textAreaRight" b="textAreaBottom"/>
                  <a:pathLst>
                    <a:path w="686" h="242">
                      <a:moveTo>
                        <a:pt x="0" y="0"/>
                      </a:moveTo>
                      <a:lnTo>
                        <a:pt x="0" y="242"/>
                      </a:lnTo>
                      <a:lnTo>
                        <a:pt x="686" y="2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Line 70"/>
                <p:cNvSpPr/>
                <p:nvPr/>
              </p:nvSpPr>
              <p:spPr>
                <a:xfrm flipV="1">
                  <a:off x="2247120" y="5082840"/>
                  <a:ext cx="103284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Freeform 71"/>
                <p:cNvSpPr/>
                <p:nvPr/>
              </p:nvSpPr>
              <p:spPr>
                <a:xfrm rot="16200000">
                  <a:off x="1690920" y="4741560"/>
                  <a:ext cx="206280" cy="892080"/>
                </a:xfrm>
                <a:custGeom>
                  <a:avLst/>
                  <a:gdLst>
                    <a:gd name="textAreaLeft" fmla="*/ 0 w 206280"/>
                    <a:gd name="textAreaRight" fmla="*/ 206640 w 206280"/>
                    <a:gd name="textAreaTop" fmla="*/ 0 h 892080"/>
                    <a:gd name="textAreaBottom" fmla="*/ 892440 h 892080"/>
                  </a:gdLst>
                  <a:ahLst/>
                  <a:rect l="textAreaLeft" t="textAreaTop" r="textAreaRight" b="textAreaBottom"/>
                  <a:pathLst>
                    <a:path w="130" h="698">
                      <a:moveTo>
                        <a:pt x="0" y="0"/>
                      </a:moveTo>
                      <a:lnTo>
                        <a:pt x="0" y="698"/>
                      </a:lnTo>
                      <a:lnTo>
                        <a:pt x="130" y="698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Freeform 72"/>
                <p:cNvSpPr/>
                <p:nvPr/>
              </p:nvSpPr>
              <p:spPr>
                <a:xfrm rot="16200000">
                  <a:off x="1940400" y="4692240"/>
                  <a:ext cx="206280" cy="1403640"/>
                </a:xfrm>
                <a:custGeom>
                  <a:avLst/>
                  <a:gdLst>
                    <a:gd name="textAreaLeft" fmla="*/ 0 w 206280"/>
                    <a:gd name="textAreaRight" fmla="*/ 206640 w 206280"/>
                    <a:gd name="textAreaTop" fmla="*/ 0 h 1403640"/>
                    <a:gd name="textAreaBottom" fmla="*/ 1404000 h 1403640"/>
                  </a:gdLst>
                  <a:ahLst/>
                  <a:rect l="textAreaLeft" t="textAreaTop" r="textAreaRight" b="textAreaBottom"/>
                  <a:pathLst>
                    <a:path w="130" h="1098">
                      <a:moveTo>
                        <a:pt x="0" y="1098"/>
                      </a:moveTo>
                      <a:lnTo>
                        <a:pt x="0" y="0"/>
                      </a:lnTo>
                      <a:lnTo>
                        <a:pt x="13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74"/>
                <p:cNvSpPr/>
                <p:nvPr/>
              </p:nvSpPr>
              <p:spPr>
                <a:xfrm rot="16200000">
                  <a:off x="3622680" y="5101920"/>
                  <a:ext cx="1440" cy="1188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18800"/>
                    <a:gd name="textAreaBottom" fmla="*/ 119160 h 118800"/>
                  </a:gdLst>
                  <a:ahLst/>
                  <a:rect l="textAreaLeft" t="textAreaTop" r="textAreaRight" b="textAreaBottom"/>
                  <a:pathLst>
                    <a:path w="1588" h="93">
                      <a:moveTo>
                        <a:pt x="0" y="93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Freeform 76"/>
                <p:cNvSpPr/>
                <p:nvPr/>
              </p:nvSpPr>
              <p:spPr>
                <a:xfrm rot="16200000">
                  <a:off x="3717000" y="5132520"/>
                  <a:ext cx="1440" cy="572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1588" h="45">
                      <a:moveTo>
                        <a:pt x="0" y="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Freeform 78"/>
                <p:cNvSpPr/>
                <p:nvPr/>
              </p:nvSpPr>
              <p:spPr>
                <a:xfrm rot="16200000">
                  <a:off x="3786840" y="5133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Line 79"/>
                <p:cNvSpPr/>
                <p:nvPr/>
              </p:nvSpPr>
              <p:spPr>
                <a:xfrm flipV="1">
                  <a:off x="3695400" y="5160600"/>
                  <a:ext cx="11988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Freeform 80"/>
                <p:cNvSpPr/>
                <p:nvPr/>
              </p:nvSpPr>
              <p:spPr>
                <a:xfrm rot="16200000">
                  <a:off x="3868560" y="4982760"/>
                  <a:ext cx="107640" cy="466560"/>
                </a:xfrm>
                <a:custGeom>
                  <a:avLst/>
                  <a:gdLst>
                    <a:gd name="textAreaLeft" fmla="*/ 0 w 107640"/>
                    <a:gd name="textAreaRight" fmla="*/ 108000 w 107640"/>
                    <a:gd name="textAreaTop" fmla="*/ 0 h 466560"/>
                    <a:gd name="textAreaBottom" fmla="*/ 466920 h 466560"/>
                  </a:gdLst>
                  <a:ahLst/>
                  <a:rect l="textAreaLeft" t="textAreaTop" r="textAreaRight" b="textAreaBottom"/>
                  <a:pathLst>
                    <a:path w="68" h="365">
                      <a:moveTo>
                        <a:pt x="0" y="365"/>
                      </a:moveTo>
                      <a:lnTo>
                        <a:pt x="0" y="0"/>
                      </a:lnTo>
                      <a:lnTo>
                        <a:pt x="6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Freeform 82"/>
                <p:cNvSpPr/>
                <p:nvPr/>
              </p:nvSpPr>
              <p:spPr>
                <a:xfrm rot="16200000">
                  <a:off x="3969720" y="5241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Freeform 84"/>
                <p:cNvSpPr/>
                <p:nvPr/>
              </p:nvSpPr>
              <p:spPr>
                <a:xfrm rot="16200000">
                  <a:off x="4038480" y="5241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Freeform 86"/>
                <p:cNvSpPr/>
                <p:nvPr/>
              </p:nvSpPr>
              <p:spPr>
                <a:xfrm rot="16200000">
                  <a:off x="4221360" y="5133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4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Freeform 88"/>
                <p:cNvSpPr/>
                <p:nvPr/>
              </p:nvSpPr>
              <p:spPr>
                <a:xfrm rot="16200000">
                  <a:off x="4290480" y="5133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Freeform 90"/>
                <p:cNvSpPr/>
                <p:nvPr/>
              </p:nvSpPr>
              <p:spPr>
                <a:xfrm rot="16200000">
                  <a:off x="4384800" y="5101200"/>
                  <a:ext cx="1440" cy="11988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19880"/>
                    <a:gd name="textAreaBottom" fmla="*/ 120240 h 119880"/>
                  </a:gdLst>
                  <a:ahLst/>
                  <a:rect l="textAreaLeft" t="textAreaTop" r="textAreaRight" b="textAreaBottom"/>
                  <a:pathLst>
                    <a:path w="1588" h="94">
                      <a:moveTo>
                        <a:pt x="0" y="0"/>
                      </a:moveTo>
                      <a:lnTo>
                        <a:pt x="0" y="9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Freeform 92"/>
                <p:cNvSpPr/>
                <p:nvPr/>
              </p:nvSpPr>
              <p:spPr>
                <a:xfrm rot="16200000">
                  <a:off x="4599000" y="5132520"/>
                  <a:ext cx="1440" cy="572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1588" h="45">
                      <a:moveTo>
                        <a:pt x="0" y="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Freeform 94"/>
                <p:cNvSpPr/>
                <p:nvPr/>
              </p:nvSpPr>
              <p:spPr>
                <a:xfrm rot="16200000">
                  <a:off x="4668840" y="513324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Freeform 96"/>
                <p:cNvSpPr/>
                <p:nvPr/>
              </p:nvSpPr>
              <p:spPr>
                <a:xfrm rot="16200000">
                  <a:off x="4763160" y="5101200"/>
                  <a:ext cx="1440" cy="11988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119880"/>
                    <a:gd name="textAreaBottom" fmla="*/ 120240 h 119880"/>
                  </a:gdLst>
                  <a:ahLst/>
                  <a:rect l="textAreaLeft" t="textAreaTop" r="textAreaRight" b="textAreaBottom"/>
                  <a:pathLst>
                    <a:path w="1588" h="94">
                      <a:moveTo>
                        <a:pt x="0" y="0"/>
                      </a:moveTo>
                      <a:lnTo>
                        <a:pt x="0" y="9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98"/>
                <p:cNvSpPr/>
                <p:nvPr/>
              </p:nvSpPr>
              <p:spPr>
                <a:xfrm rot="16200000">
                  <a:off x="4762800" y="4975200"/>
                  <a:ext cx="1440" cy="37188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71880"/>
                    <a:gd name="textAreaBottom" fmla="*/ 372240 h 371880"/>
                  </a:gdLst>
                  <a:ahLst/>
                  <a:rect l="textAreaLeft" t="textAreaTop" r="textAreaRight" b="textAreaBottom"/>
                  <a:pathLst>
                    <a:path w="1588" h="291">
                      <a:moveTo>
                        <a:pt x="0" y="0"/>
                      </a:moveTo>
                      <a:lnTo>
                        <a:pt x="0" y="291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Freeform 100"/>
                <p:cNvSpPr/>
                <p:nvPr/>
              </p:nvSpPr>
              <p:spPr>
                <a:xfrm rot="16200000">
                  <a:off x="4857840" y="4943880"/>
                  <a:ext cx="1440" cy="43452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434520"/>
                    <a:gd name="textAreaBottom" fmla="*/ 434880 h 434520"/>
                  </a:gdLst>
                  <a:ahLst/>
                  <a:rect l="textAreaLeft" t="textAreaTop" r="textAreaRight" b="textAreaBottom"/>
                  <a:pathLst>
                    <a:path w="1588" h="340">
                      <a:moveTo>
                        <a:pt x="0" y="0"/>
                      </a:moveTo>
                      <a:lnTo>
                        <a:pt x="0" y="34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101"/>
                <p:cNvSpPr/>
                <p:nvPr/>
              </p:nvSpPr>
              <p:spPr>
                <a:xfrm flipV="1">
                  <a:off x="4194000" y="5160600"/>
                  <a:ext cx="43452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Freeform 102"/>
                <p:cNvSpPr/>
                <p:nvPr/>
              </p:nvSpPr>
              <p:spPr>
                <a:xfrm rot="16200000">
                  <a:off x="4411080" y="5046120"/>
                  <a:ext cx="107640" cy="339840"/>
                </a:xfrm>
                <a:custGeom>
                  <a:avLst/>
                  <a:gdLst>
                    <a:gd name="textAreaLeft" fmla="*/ 0 w 107640"/>
                    <a:gd name="textAreaRight" fmla="*/ 108000 w 107640"/>
                    <a:gd name="textAreaTop" fmla="*/ 0 h 339840"/>
                    <a:gd name="textAreaBottom" fmla="*/ 340200 h 339840"/>
                  </a:gdLst>
                  <a:ahLst/>
                  <a:rect l="textAreaLeft" t="textAreaTop" r="textAreaRight" b="textAreaBottom"/>
                  <a:pathLst>
                    <a:path w="68" h="266">
                      <a:moveTo>
                        <a:pt x="0" y="0"/>
                      </a:moveTo>
                      <a:lnTo>
                        <a:pt x="0" y="266"/>
                      </a:lnTo>
                      <a:lnTo>
                        <a:pt x="68" y="26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103"/>
                <p:cNvSpPr/>
                <p:nvPr/>
              </p:nvSpPr>
              <p:spPr>
                <a:xfrm flipV="1">
                  <a:off x="4168440" y="5268600"/>
                  <a:ext cx="46656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104"/>
                <p:cNvSpPr/>
                <p:nvPr/>
              </p:nvSpPr>
              <p:spPr>
                <a:xfrm rot="16200000">
                  <a:off x="3346560" y="4681800"/>
                  <a:ext cx="226800" cy="1403640"/>
                </a:xfrm>
                <a:custGeom>
                  <a:avLst/>
                  <a:gdLst>
                    <a:gd name="textAreaLeft" fmla="*/ 0 w 226800"/>
                    <a:gd name="textAreaRight" fmla="*/ 227160 w 226800"/>
                    <a:gd name="textAreaTop" fmla="*/ 0 h 1403640"/>
                    <a:gd name="textAreaBottom" fmla="*/ 1404000 h 1403640"/>
                  </a:gdLst>
                  <a:ahLst/>
                  <a:rect l="textAreaLeft" t="textAreaTop" r="textAreaRight" b="textAreaBottom"/>
                  <a:pathLst>
                    <a:path w="143" h="1098">
                      <a:moveTo>
                        <a:pt x="0" y="0"/>
                      </a:moveTo>
                      <a:lnTo>
                        <a:pt x="0" y="1098"/>
                      </a:lnTo>
                      <a:lnTo>
                        <a:pt x="143" y="1098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Freeform 105"/>
                <p:cNvSpPr/>
                <p:nvPr/>
              </p:nvSpPr>
              <p:spPr>
                <a:xfrm rot="16200000">
                  <a:off x="3030120" y="5218920"/>
                  <a:ext cx="691920" cy="1248840"/>
                </a:xfrm>
                <a:custGeom>
                  <a:avLst/>
                  <a:gdLst>
                    <a:gd name="textAreaLeft" fmla="*/ 0 w 691920"/>
                    <a:gd name="textAreaRight" fmla="*/ 691920 w 691920"/>
                    <a:gd name="textAreaTop" fmla="*/ 0 h 1248840"/>
                    <a:gd name="textAreaBottom" fmla="*/ 1249200 h 1248840"/>
                  </a:gdLst>
                  <a:ahLst/>
                  <a:rect l="textAreaLeft" t="textAreaTop" r="textAreaRight" b="textAreaBottom"/>
                  <a:pathLst>
                    <a:path w="436" h="977">
                      <a:moveTo>
                        <a:pt x="0" y="977"/>
                      </a:moveTo>
                      <a:lnTo>
                        <a:pt x="0" y="0"/>
                      </a:lnTo>
                      <a:lnTo>
                        <a:pt x="43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Freeform 107"/>
                <p:cNvSpPr/>
                <p:nvPr/>
              </p:nvSpPr>
              <p:spPr>
                <a:xfrm rot="16200000">
                  <a:off x="5229360" y="6125040"/>
                  <a:ext cx="1440" cy="572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1588" h="45">
                      <a:moveTo>
                        <a:pt x="0" y="45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Freeform 109"/>
                <p:cNvSpPr/>
                <p:nvPr/>
              </p:nvSpPr>
              <p:spPr>
                <a:xfrm rot="16200000">
                  <a:off x="5299200" y="612576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Freeform 110"/>
                <p:cNvSpPr/>
                <p:nvPr/>
              </p:nvSpPr>
              <p:spPr>
                <a:xfrm rot="16200000">
                  <a:off x="4622040" y="5546160"/>
                  <a:ext cx="34920" cy="1251360"/>
                </a:xfrm>
                <a:custGeom>
                  <a:avLst/>
                  <a:gdLst>
                    <a:gd name="textAreaLeft" fmla="*/ 0 w 34920"/>
                    <a:gd name="textAreaRight" fmla="*/ 34920 w 34920"/>
                    <a:gd name="textAreaTop" fmla="*/ 0 h 1251360"/>
                    <a:gd name="textAreaBottom" fmla="*/ 1251720 h 1251360"/>
                  </a:gdLst>
                  <a:ahLst/>
                  <a:rect l="textAreaLeft" t="textAreaTop" r="textAreaRight" b="textAreaBottom"/>
                  <a:pathLst>
                    <a:path w="22" h="979">
                      <a:moveTo>
                        <a:pt x="0" y="0"/>
                      </a:moveTo>
                      <a:lnTo>
                        <a:pt x="0" y="979"/>
                      </a:lnTo>
                      <a:lnTo>
                        <a:pt x="22" y="979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111"/>
                <p:cNvSpPr/>
                <p:nvPr/>
              </p:nvSpPr>
              <p:spPr>
                <a:xfrm rot="16200000">
                  <a:off x="3930840" y="6265800"/>
                  <a:ext cx="949320" cy="796320"/>
                </a:xfrm>
                <a:custGeom>
                  <a:avLst/>
                  <a:gdLst>
                    <a:gd name="textAreaLeft" fmla="*/ 0 w 949320"/>
                    <a:gd name="textAreaRight" fmla="*/ 949680 w 949320"/>
                    <a:gd name="textAreaTop" fmla="*/ 0 h 796320"/>
                    <a:gd name="textAreaBottom" fmla="*/ 796680 h 796320"/>
                  </a:gdLst>
                  <a:ahLst/>
                  <a:rect l="textAreaLeft" t="textAreaTop" r="textAreaRight" b="textAreaBottom"/>
                  <a:pathLst>
                    <a:path w="598" h="623">
                      <a:moveTo>
                        <a:pt x="0" y="623"/>
                      </a:moveTo>
                      <a:lnTo>
                        <a:pt x="0" y="0"/>
                      </a:lnTo>
                      <a:lnTo>
                        <a:pt x="59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Freeform 113"/>
                <p:cNvSpPr/>
                <p:nvPr/>
              </p:nvSpPr>
              <p:spPr>
                <a:xfrm rot="16200000">
                  <a:off x="5264640" y="6285960"/>
                  <a:ext cx="436320" cy="56160"/>
                </a:xfrm>
                <a:custGeom>
                  <a:avLst/>
                  <a:gdLst>
                    <a:gd name="textAreaLeft" fmla="*/ 0 w 436320"/>
                    <a:gd name="textAreaRight" fmla="*/ 436680 w 43632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275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27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Freeform 115"/>
                <p:cNvSpPr/>
                <p:nvPr/>
              </p:nvSpPr>
              <p:spPr>
                <a:xfrm rot="16200000">
                  <a:off x="5441400" y="6393600"/>
                  <a:ext cx="220680" cy="56160"/>
                </a:xfrm>
                <a:custGeom>
                  <a:avLst/>
                  <a:gdLst>
                    <a:gd name="textAreaLeft" fmla="*/ 0 w 220680"/>
                    <a:gd name="textAreaRight" fmla="*/ 221040 w 22068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39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139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Freeform 117"/>
                <p:cNvSpPr/>
                <p:nvPr/>
              </p:nvSpPr>
              <p:spPr>
                <a:xfrm rot="16200000">
                  <a:off x="5685480" y="6048360"/>
                  <a:ext cx="98280" cy="56160"/>
                </a:xfrm>
                <a:custGeom>
                  <a:avLst/>
                  <a:gdLst>
                    <a:gd name="textAreaLeft" fmla="*/ 0 w 98280"/>
                    <a:gd name="textAreaRight" fmla="*/ 98640 w 9828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62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62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Freeform 119"/>
                <p:cNvSpPr/>
                <p:nvPr/>
              </p:nvSpPr>
              <p:spPr>
                <a:xfrm rot="16200000">
                  <a:off x="5802840" y="609696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Freeform 120"/>
                <p:cNvSpPr/>
                <p:nvPr/>
              </p:nvSpPr>
              <p:spPr>
                <a:xfrm rot="16200000">
                  <a:off x="5490360" y="6253560"/>
                  <a:ext cx="406080" cy="150840"/>
                </a:xfrm>
                <a:custGeom>
                  <a:avLst/>
                  <a:gdLst>
                    <a:gd name="textAreaLeft" fmla="*/ 0 w 406080"/>
                    <a:gd name="textAreaRight" fmla="*/ 406440 w 406080"/>
                    <a:gd name="textAreaTop" fmla="*/ 0 h 150840"/>
                    <a:gd name="textAreaBottom" fmla="*/ 151200 h 150840"/>
                  </a:gdLst>
                  <a:ahLst/>
                  <a:rect l="textAreaLeft" t="textAreaTop" r="textAreaRight" b="textAreaBottom"/>
                  <a:pathLst>
                    <a:path w="256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256" y="118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Line 121"/>
                <p:cNvSpPr/>
                <p:nvPr/>
              </p:nvSpPr>
              <p:spPr>
                <a:xfrm flipV="1">
                  <a:off x="5454720" y="6530760"/>
                  <a:ext cx="15084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Freeform 122"/>
                <p:cNvSpPr/>
                <p:nvPr/>
              </p:nvSpPr>
              <p:spPr>
                <a:xfrm rot="16200000">
                  <a:off x="4910400" y="6437520"/>
                  <a:ext cx="606240" cy="796320"/>
                </a:xfrm>
                <a:custGeom>
                  <a:avLst/>
                  <a:gdLst>
                    <a:gd name="textAreaLeft" fmla="*/ 0 w 606240"/>
                    <a:gd name="textAreaRight" fmla="*/ 606600 w 606240"/>
                    <a:gd name="textAreaTop" fmla="*/ 0 h 796320"/>
                    <a:gd name="textAreaBottom" fmla="*/ 796680 h 796320"/>
                  </a:gdLst>
                  <a:ahLst/>
                  <a:rect l="textAreaLeft" t="textAreaTop" r="textAreaRight" b="textAreaBottom"/>
                  <a:pathLst>
                    <a:path w="382" h="623">
                      <a:moveTo>
                        <a:pt x="0" y="0"/>
                      </a:moveTo>
                      <a:lnTo>
                        <a:pt x="0" y="623"/>
                      </a:lnTo>
                      <a:lnTo>
                        <a:pt x="382" y="62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Freeform 123"/>
                <p:cNvSpPr/>
                <p:nvPr/>
              </p:nvSpPr>
              <p:spPr>
                <a:xfrm rot="16200000">
                  <a:off x="4738680" y="7210440"/>
                  <a:ext cx="709560" cy="566280"/>
                </a:xfrm>
                <a:custGeom>
                  <a:avLst/>
                  <a:gdLst>
                    <a:gd name="textAreaLeft" fmla="*/ 0 w 709560"/>
                    <a:gd name="textAreaRight" fmla="*/ 709920 w 709560"/>
                    <a:gd name="textAreaTop" fmla="*/ 0 h 566280"/>
                    <a:gd name="textAreaBottom" fmla="*/ 566640 h 566280"/>
                  </a:gdLst>
                  <a:ahLst/>
                  <a:rect l="textAreaLeft" t="textAreaTop" r="textAreaRight" b="textAreaBottom"/>
                  <a:pathLst>
                    <a:path w="447" h="443">
                      <a:moveTo>
                        <a:pt x="0" y="443"/>
                      </a:moveTo>
                      <a:lnTo>
                        <a:pt x="0" y="0"/>
                      </a:lnTo>
                      <a:lnTo>
                        <a:pt x="44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Freeform 125"/>
                <p:cNvSpPr/>
                <p:nvPr/>
              </p:nvSpPr>
              <p:spPr>
                <a:xfrm rot="16200000">
                  <a:off x="4484880" y="6374880"/>
                  <a:ext cx="2378160" cy="568800"/>
                </a:xfrm>
                <a:custGeom>
                  <a:avLst/>
                  <a:gdLst>
                    <a:gd name="textAreaLeft" fmla="*/ 0 w 2378160"/>
                    <a:gd name="textAreaRight" fmla="*/ 2378520 w 2378160"/>
                    <a:gd name="textAreaTop" fmla="*/ 0 h 568800"/>
                    <a:gd name="textAreaBottom" fmla="*/ 569160 h 568800"/>
                  </a:gdLst>
                  <a:ahLst/>
                  <a:rect l="textAreaLeft" t="textAreaTop" r="textAreaRight" b="textAreaBottom"/>
                  <a:pathLst>
                    <a:path w="1498" h="445">
                      <a:moveTo>
                        <a:pt x="0" y="0"/>
                      </a:moveTo>
                      <a:lnTo>
                        <a:pt x="0" y="445"/>
                      </a:lnTo>
                      <a:lnTo>
                        <a:pt x="1498" y="44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Freeform 126"/>
                <p:cNvSpPr/>
                <p:nvPr/>
              </p:nvSpPr>
              <p:spPr>
                <a:xfrm rot="16200000">
                  <a:off x="5486040" y="7745400"/>
                  <a:ext cx="168120" cy="374400"/>
                </a:xfrm>
                <a:custGeom>
                  <a:avLst/>
                  <a:gdLst>
                    <a:gd name="textAreaLeft" fmla="*/ 0 w 168120"/>
                    <a:gd name="textAreaRight" fmla="*/ 168480 w 168120"/>
                    <a:gd name="textAreaTop" fmla="*/ 0 h 374400"/>
                    <a:gd name="textAreaBottom" fmla="*/ 374760 h 374400"/>
                  </a:gdLst>
                  <a:ahLst/>
                  <a:rect l="textAreaLeft" t="textAreaTop" r="textAreaRight" b="textAreaBottom"/>
                  <a:pathLst>
                    <a:path w="106" h="293">
                      <a:moveTo>
                        <a:pt x="0" y="293"/>
                      </a:moveTo>
                      <a:lnTo>
                        <a:pt x="0" y="0"/>
                      </a:lnTo>
                      <a:lnTo>
                        <a:pt x="10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128"/>
                <p:cNvSpPr/>
                <p:nvPr/>
              </p:nvSpPr>
              <p:spPr>
                <a:xfrm rot="16200000">
                  <a:off x="6059880" y="5949720"/>
                  <a:ext cx="104760" cy="57240"/>
                </a:xfrm>
                <a:custGeom>
                  <a:avLst/>
                  <a:gdLst>
                    <a:gd name="textAreaLeft" fmla="*/ 0 w 104760"/>
                    <a:gd name="textAreaRight" fmla="*/ 105120 w 104760"/>
                    <a:gd name="textAreaTop" fmla="*/ 0 h 57240"/>
                    <a:gd name="textAreaBottom" fmla="*/ 57600 h 57240"/>
                  </a:gdLst>
                  <a:ahLst/>
                  <a:rect l="textAreaLeft" t="textAreaTop" r="textAreaRight" b="textAreaBottom"/>
                  <a:pathLst>
                    <a:path w="66" h="45">
                      <a:moveTo>
                        <a:pt x="0" y="45"/>
                      </a:moveTo>
                      <a:lnTo>
                        <a:pt x="0" y="0"/>
                      </a:lnTo>
                      <a:lnTo>
                        <a:pt x="6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Freeform 130"/>
                <p:cNvSpPr/>
                <p:nvPr/>
              </p:nvSpPr>
              <p:spPr>
                <a:xfrm rot="16200000">
                  <a:off x="6181200" y="6001920"/>
                  <a:ext cx="1440" cy="5616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588" h="44">
                      <a:moveTo>
                        <a:pt x="0" y="0"/>
                      </a:moveTo>
                      <a:lnTo>
                        <a:pt x="0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Freeform 131"/>
                <p:cNvSpPr/>
                <p:nvPr/>
              </p:nvSpPr>
              <p:spPr>
                <a:xfrm rot="16200000">
                  <a:off x="4965840" y="6835320"/>
                  <a:ext cx="1986120" cy="376920"/>
                </a:xfrm>
                <a:custGeom>
                  <a:avLst/>
                  <a:gdLst>
                    <a:gd name="textAreaLeft" fmla="*/ 0 w 1986120"/>
                    <a:gd name="textAreaRight" fmla="*/ 1986480 w 1986120"/>
                    <a:gd name="textAreaTop" fmla="*/ 0 h 376920"/>
                    <a:gd name="textAreaBottom" fmla="*/ 377280 h 376920"/>
                  </a:gdLst>
                  <a:ahLst/>
                  <a:rect l="textAreaLeft" t="textAreaTop" r="textAreaRight" b="textAreaBottom"/>
                  <a:pathLst>
                    <a:path w="1251" h="295">
                      <a:moveTo>
                        <a:pt x="0" y="0"/>
                      </a:moveTo>
                      <a:lnTo>
                        <a:pt x="0" y="295"/>
                      </a:lnTo>
                      <a:lnTo>
                        <a:pt x="1251" y="29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Freeform 132"/>
                <p:cNvSpPr/>
                <p:nvPr/>
              </p:nvSpPr>
              <p:spPr>
                <a:xfrm rot="16200000">
                  <a:off x="5612040" y="8168760"/>
                  <a:ext cx="614160" cy="310320"/>
                </a:xfrm>
                <a:custGeom>
                  <a:avLst/>
                  <a:gdLst>
                    <a:gd name="textAreaLeft" fmla="*/ 0 w 614160"/>
                    <a:gd name="textAreaRight" fmla="*/ 614520 w 614160"/>
                    <a:gd name="textAreaTop" fmla="*/ 0 h 310320"/>
                    <a:gd name="textAreaBottom" fmla="*/ 310680 h 310320"/>
                  </a:gdLst>
                  <a:ahLst/>
                  <a:rect l="textAreaLeft" t="textAreaTop" r="textAreaRight" b="textAreaBottom"/>
                  <a:pathLst>
                    <a:path w="387" h="243">
                      <a:moveTo>
                        <a:pt x="0" y="243"/>
                      </a:moveTo>
                      <a:lnTo>
                        <a:pt x="0" y="0"/>
                      </a:lnTo>
                      <a:lnTo>
                        <a:pt x="38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Freeform 134"/>
                <p:cNvSpPr/>
                <p:nvPr/>
              </p:nvSpPr>
              <p:spPr>
                <a:xfrm rot="16200000">
                  <a:off x="5250960" y="6354000"/>
                  <a:ext cx="2227320" cy="56160"/>
                </a:xfrm>
                <a:custGeom>
                  <a:avLst/>
                  <a:gdLst>
                    <a:gd name="textAreaLeft" fmla="*/ 0 w 2227320"/>
                    <a:gd name="textAreaRight" fmla="*/ 2227680 w 222732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1403" h="44">
                      <a:moveTo>
                        <a:pt x="0" y="44"/>
                      </a:moveTo>
                      <a:lnTo>
                        <a:pt x="0" y="0"/>
                      </a:lnTo>
                      <a:lnTo>
                        <a:pt x="1403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Freeform 136"/>
                <p:cNvSpPr/>
                <p:nvPr/>
              </p:nvSpPr>
              <p:spPr>
                <a:xfrm rot="16200000">
                  <a:off x="6064920" y="7098840"/>
                  <a:ext cx="738000" cy="56160"/>
                </a:xfrm>
                <a:custGeom>
                  <a:avLst/>
                  <a:gdLst>
                    <a:gd name="textAreaLeft" fmla="*/ 0 w 738000"/>
                    <a:gd name="textAreaRight" fmla="*/ 738360 w 738000"/>
                    <a:gd name="textAreaTop" fmla="*/ 0 h 56160"/>
                    <a:gd name="textAreaBottom" fmla="*/ 56520 h 56160"/>
                  </a:gdLst>
                  <a:ahLst/>
                  <a:rect l="textAreaLeft" t="textAreaTop" r="textAreaRight" b="textAreaBottom"/>
                  <a:pathLst>
                    <a:path w="465" h="44">
                      <a:moveTo>
                        <a:pt x="0" y="0"/>
                      </a:moveTo>
                      <a:lnTo>
                        <a:pt x="0" y="44"/>
                      </a:lnTo>
                      <a:lnTo>
                        <a:pt x="465" y="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Freeform 137"/>
                <p:cNvSpPr/>
                <p:nvPr/>
              </p:nvSpPr>
              <p:spPr>
                <a:xfrm rot="16200000">
                  <a:off x="5675760" y="7907400"/>
                  <a:ext cx="1135080" cy="311760"/>
                </a:xfrm>
                <a:custGeom>
                  <a:avLst/>
                  <a:gdLst>
                    <a:gd name="textAreaLeft" fmla="*/ 0 w 1135080"/>
                    <a:gd name="textAreaRight" fmla="*/ 1135440 w 1135080"/>
                    <a:gd name="textAreaTop" fmla="*/ 0 h 311760"/>
                    <a:gd name="textAreaBottom" fmla="*/ 312120 h 311760"/>
                  </a:gdLst>
                  <a:ahLst/>
                  <a:rect l="textAreaLeft" t="textAreaTop" r="textAreaRight" b="textAreaBottom"/>
                  <a:pathLst>
                    <a:path w="715" h="244">
                      <a:moveTo>
                        <a:pt x="0" y="0"/>
                      </a:moveTo>
                      <a:lnTo>
                        <a:pt x="0" y="244"/>
                      </a:lnTo>
                      <a:lnTo>
                        <a:pt x="715" y="24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Rectangle 138"/>
                <p:cNvSpPr/>
                <p:nvPr/>
              </p:nvSpPr>
              <p:spPr>
                <a:xfrm rot="16200000">
                  <a:off x="5277240" y="616140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9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Rectangle 139"/>
                <p:cNvSpPr/>
                <p:nvPr/>
              </p:nvSpPr>
              <p:spPr>
                <a:xfrm rot="16200000">
                  <a:off x="5784480" y="615312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9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Rectangle 140"/>
                <p:cNvSpPr/>
                <p:nvPr/>
              </p:nvSpPr>
              <p:spPr>
                <a:xfrm rot="16200000">
                  <a:off x="6413760" y="752328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9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Rectangle 141"/>
                <p:cNvSpPr/>
                <p:nvPr/>
              </p:nvSpPr>
              <p:spPr>
                <a:xfrm rot="16200000">
                  <a:off x="6135840" y="6085800"/>
                  <a:ext cx="156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Rectangle 142"/>
                <p:cNvSpPr/>
                <p:nvPr/>
              </p:nvSpPr>
              <p:spPr>
                <a:xfrm rot="16200000">
                  <a:off x="3353400" y="380844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7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Rectangle 143"/>
                <p:cNvSpPr/>
                <p:nvPr/>
              </p:nvSpPr>
              <p:spPr>
                <a:xfrm rot="16200000">
                  <a:off x="3253320" y="402120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8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ectangle 144"/>
                <p:cNvSpPr/>
                <p:nvPr/>
              </p:nvSpPr>
              <p:spPr>
                <a:xfrm rot="16200000">
                  <a:off x="2167920" y="478332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9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Rectangle 145"/>
                <p:cNvSpPr/>
                <p:nvPr/>
              </p:nvSpPr>
              <p:spPr>
                <a:xfrm rot="16200000">
                  <a:off x="834840" y="2449800"/>
                  <a:ext cx="156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Rectangle 148"/>
                <p:cNvSpPr/>
                <p:nvPr/>
              </p:nvSpPr>
              <p:spPr>
                <a:xfrm rot="16200000">
                  <a:off x="4169520" y="5284440"/>
                  <a:ext cx="104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8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89" name="グループ化 157"/>
          <p:cNvGrpSpPr/>
          <p:nvPr/>
        </p:nvGrpSpPr>
        <p:grpSpPr>
          <a:xfrm>
            <a:off x="6626160" y="8277120"/>
            <a:ext cx="164880" cy="354240"/>
            <a:chOff x="6626160" y="8277120"/>
            <a:chExt cx="164880" cy="354240"/>
          </a:xfrm>
        </p:grpSpPr>
        <p:sp>
          <p:nvSpPr>
            <p:cNvPr id="190" name="Line 149"/>
            <p:cNvSpPr/>
            <p:nvPr/>
          </p:nvSpPr>
          <p:spPr>
            <a:xfrm flipV="1">
              <a:off x="6656040" y="8278560"/>
              <a:ext cx="1440" cy="3528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50"/>
            <p:cNvSpPr/>
            <p:nvPr/>
          </p:nvSpPr>
          <p:spPr>
            <a:xfrm flipV="1">
              <a:off x="6626160" y="8629920"/>
              <a:ext cx="6156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1"/>
            <p:cNvSpPr/>
            <p:nvPr/>
          </p:nvSpPr>
          <p:spPr>
            <a:xfrm flipV="1">
              <a:off x="6626160" y="8277120"/>
              <a:ext cx="6156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2"/>
            <p:cNvSpPr/>
            <p:nvPr/>
          </p:nvSpPr>
          <p:spPr>
            <a:xfrm rot="16200000">
              <a:off x="6659280" y="8381520"/>
              <a:ext cx="156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7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0T23:31:48Z</dcterms:created>
  <dc:creator>koba</dc:creator>
  <dc:description/>
  <dc:language>en-US</dc:language>
  <cp:lastModifiedBy>gilb01</cp:lastModifiedBy>
  <dcterms:modified xsi:type="dcterms:W3CDTF">2011-10-14T15:08:55Z</dcterms:modified>
  <cp:revision>2</cp:revision>
  <dc:subject/>
  <dc:title>スライド 1</dc:title>
</cp:coreProperties>
</file>